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3" r:id="rId3"/>
    <p:sldId id="264" r:id="rId4"/>
    <p:sldId id="265" r:id="rId5"/>
    <p:sldId id="266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1/07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65042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01386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148221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36972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1/07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3123" y="5799958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87849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Simó</a:t>
            </a:r>
            <a:r>
              <a:rPr lang="en-GB" dirty="0"/>
              <a:t> et al (2018) Diabetologia DOI 10.1007/s00125-018-4692-1</a:t>
            </a:r>
          </a:p>
          <a:p>
            <a:r>
              <a:rPr lang="en-GB" sz="1200" dirty="0"/>
              <a:t>Schematic: © BMJ Publishing Group Limited. Adapted from </a:t>
            </a:r>
            <a:r>
              <a:rPr lang="en-GB" sz="1200" dirty="0" err="1"/>
              <a:t>Simó</a:t>
            </a:r>
            <a:r>
              <a:rPr lang="en-GB" sz="1200" dirty="0"/>
              <a:t> and Hernández (2012). </a:t>
            </a:r>
            <a:r>
              <a:rPr lang="en-GB" sz="1200" dirty="0" err="1"/>
              <a:t>mfERG</a:t>
            </a:r>
            <a:r>
              <a:rPr lang="en-GB" sz="1200" dirty="0"/>
              <a:t> image, distributed under the terms of the CC BY-SA 4.0 License (https://creativecommons.org/licenses/by-sa/4.0/); microperimetry image, used with permission from </a:t>
            </a:r>
            <a:r>
              <a:rPr lang="en-GB" sz="1200" dirty="0" err="1"/>
              <a:t>CenterVue</a:t>
            </a:r>
            <a:r>
              <a:rPr lang="en-GB" sz="1200" dirty="0"/>
              <a:t> </a:t>
            </a:r>
            <a:r>
              <a:rPr lang="en-GB" sz="1200" dirty="0" err="1"/>
              <a:t>SpA</a:t>
            </a:r>
            <a:r>
              <a:rPr lang="en-GB" sz="1200" dirty="0"/>
              <a:t>; SD-OCT image, 3D OCT-2000, used by permission of Topcon GB Ltd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Natural history of diabetic retinopathy, based on retinal microvascular disease progression, and current treatment option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501871C-3941-4DD3-AA91-E7A8BED929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4331" y="1094837"/>
            <a:ext cx="7235337" cy="4668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87129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Simó</a:t>
            </a:r>
            <a:r>
              <a:rPr lang="en-GB" dirty="0"/>
              <a:t> et al (2018) Diabetologia DOI 10.1007/s00125-018-4692-1</a:t>
            </a:r>
          </a:p>
          <a:p>
            <a:r>
              <a:rPr lang="en-GB" sz="1200" dirty="0"/>
              <a:t>Healthy retina: adapted from illustration by R. </a:t>
            </a:r>
            <a:r>
              <a:rPr lang="en-GB" sz="1200" dirty="0" err="1"/>
              <a:t>Davidowitz</a:t>
            </a:r>
            <a:r>
              <a:rPr lang="en-GB" sz="1200" dirty="0"/>
              <a:t> in Duh et al (2017),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. Glial-mediated neurovascular coupling: adapted from illustration by A. Mishra in Newman (2013); © SAGE Publication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308304" y="5688832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2693" y="338255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mposition of the </a:t>
            </a:r>
            <a:r>
              <a:rPr lang="en-GB" sz="2000" b="1"/>
              <a:t>retinal neurovascular unit</a:t>
            </a:r>
            <a:endParaRPr lang="en-GB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AAACBD8-ADAB-4B51-B7F5-7B36687EA0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7664" y="1124744"/>
            <a:ext cx="5961004" cy="4416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49276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Simó</a:t>
            </a:r>
            <a:r>
              <a:rPr lang="en-GB" dirty="0"/>
              <a:t> et al (2018) Diabetologia DOI 10.1007/s00125-018-4692-1 </a:t>
            </a:r>
          </a:p>
          <a:p>
            <a:r>
              <a:rPr lang="en-GB" sz="1200" dirty="0"/>
              <a:t>© The Authors 2018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requency-doubling perimetry field tests with corresponding OCT angiograms and macular OCT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B0223ABF-0A2A-48E9-8017-946C6D56E777}"/>
              </a:ext>
            </a:extLst>
          </p:cNvPr>
          <p:cNvGrpSpPr/>
          <p:nvPr/>
        </p:nvGrpSpPr>
        <p:grpSpPr>
          <a:xfrm>
            <a:off x="395535" y="887963"/>
            <a:ext cx="8748465" cy="4774947"/>
            <a:chOff x="395536" y="622316"/>
            <a:chExt cx="8748465" cy="4774947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A3886E2-770F-4EEF-8553-56FF8BD81EDA}"/>
                </a:ext>
              </a:extLst>
            </p:cNvPr>
            <p:cNvGrpSpPr/>
            <p:nvPr/>
          </p:nvGrpSpPr>
          <p:grpSpPr>
            <a:xfrm>
              <a:off x="395536" y="1245874"/>
              <a:ext cx="8515913" cy="4151389"/>
              <a:chOff x="322213" y="1124744"/>
              <a:chExt cx="8515913" cy="4151389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A0AF4C06-D3F8-4775-8DCA-D094EAD8DC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849823" y="1124744"/>
                <a:ext cx="4881102" cy="4151389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839BBF7-9CCB-4D4E-80A4-9783E13F0F33}"/>
                  </a:ext>
                </a:extLst>
              </p:cNvPr>
              <p:cNvSpPr txBox="1"/>
              <p:nvPr/>
            </p:nvSpPr>
            <p:spPr>
              <a:xfrm>
                <a:off x="6876256" y="3126010"/>
                <a:ext cx="1961870" cy="2143393"/>
              </a:xfrm>
              <a:prstGeom prst="round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600"/>
                  </a:spcAft>
                </a:pPr>
                <a:r>
                  <a:rPr lang="en-GB" sz="1200" dirty="0"/>
                  <a:t>62 year </a:t>
                </a:r>
                <a:r>
                  <a:rPr lang="en-GB" sz="1200"/>
                  <a:t>old woman with</a:t>
                </a:r>
                <a:r>
                  <a:rPr lang="en-GB" sz="1200" dirty="0"/>
                  <a:t>: </a:t>
                </a:r>
              </a:p>
              <a:p>
                <a:pPr marL="171450" indent="-171450">
                  <a:spcAft>
                    <a:spcPts val="600"/>
                  </a:spcAft>
                  <a:buFont typeface="Wingdings" panose="05000000000000000000" pitchFamily="2" charset="2"/>
                  <a:buChar char="§"/>
                </a:pPr>
                <a:r>
                  <a:rPr lang="en-GB" sz="1200" dirty="0"/>
                  <a:t>18 year history of     type 2 diabetes</a:t>
                </a:r>
              </a:p>
              <a:p>
                <a:pPr marL="171450" indent="-171450">
                  <a:spcAft>
                    <a:spcPts val="600"/>
                  </a:spcAft>
                  <a:buFont typeface="Wingdings" panose="05000000000000000000" pitchFamily="2" charset="2"/>
                  <a:buChar char="§"/>
                </a:pPr>
                <a:r>
                  <a:rPr lang="en-GB" sz="1200" dirty="0"/>
                  <a:t>20/25 visual acuity</a:t>
                </a:r>
              </a:p>
              <a:p>
                <a:pPr marL="171450" indent="-171450">
                  <a:spcAft>
                    <a:spcPts val="600"/>
                  </a:spcAft>
                  <a:buFont typeface="Wingdings" panose="05000000000000000000" pitchFamily="2" charset="2"/>
                  <a:buChar char="§"/>
                </a:pPr>
                <a:r>
                  <a:rPr lang="en-GB" sz="1200" dirty="0"/>
                  <a:t>Gastroparesis</a:t>
                </a:r>
              </a:p>
              <a:p>
                <a:pPr marL="171450" indent="-171450">
                  <a:spcAft>
                    <a:spcPts val="600"/>
                  </a:spcAft>
                  <a:buFont typeface="Wingdings" panose="05000000000000000000" pitchFamily="2" charset="2"/>
                  <a:buChar char="§"/>
                </a:pPr>
                <a:r>
                  <a:rPr lang="en-GB" sz="1200" dirty="0"/>
                  <a:t>Normal clinical examination and fluorescein angiogram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4EC35325-8E7C-4997-A80F-1614755D529D}"/>
                  </a:ext>
                </a:extLst>
              </p:cNvPr>
              <p:cNvSpPr txBox="1"/>
              <p:nvPr/>
            </p:nvSpPr>
            <p:spPr>
              <a:xfrm>
                <a:off x="322213" y="3126010"/>
                <a:ext cx="1692499" cy="715089"/>
              </a:xfrm>
              <a:prstGeom prst="round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Healthy 58 year old woman with 20/16 visual acuity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CD815E15-4948-41EB-AE03-B1F9D01D81E8}"/>
                </a:ext>
              </a:extLst>
            </p:cNvPr>
            <p:cNvGrpSpPr/>
            <p:nvPr/>
          </p:nvGrpSpPr>
          <p:grpSpPr>
            <a:xfrm>
              <a:off x="7091460" y="622316"/>
              <a:ext cx="2052541" cy="707887"/>
              <a:chOff x="13834642" y="-3082245"/>
              <a:chExt cx="2052541" cy="707887"/>
            </a:xfrm>
          </p:grpSpPr>
          <p:sp>
            <p:nvSpPr>
              <p:cNvPr id="29" name="Rectangle: Rounded Corners 28">
                <a:extLst>
                  <a:ext uri="{FF2B5EF4-FFF2-40B4-BE49-F238E27FC236}">
                    <a16:creationId xmlns:a16="http://schemas.microsoft.com/office/drawing/2014/main" id="{C4C42D09-D81E-4F30-9C75-FB4C413517F1}"/>
                  </a:ext>
                </a:extLst>
              </p:cNvPr>
              <p:cNvSpPr/>
              <p:nvPr/>
            </p:nvSpPr>
            <p:spPr>
              <a:xfrm>
                <a:off x="13834642" y="-3082245"/>
                <a:ext cx="1903675" cy="707887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F67D0256-7519-4344-9D15-D3AD053D2B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52514" y="-2932247"/>
                <a:ext cx="21602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90265F8B-7B5D-434D-BFC2-5B8AFD47BD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52514" y="-2707688"/>
                <a:ext cx="242170" cy="0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619D8D20-4A37-4FD8-B9A0-6E2FF807C4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52514" y="-2491664"/>
                <a:ext cx="242170" cy="0"/>
              </a:xfrm>
              <a:prstGeom prst="straightConnector1">
                <a:avLst/>
              </a:prstGeom>
              <a:ln w="28575">
                <a:solidFill>
                  <a:srgbClr val="FFFF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5262BB7-5701-4BB4-BDE8-28E1E7F6CB49}"/>
                  </a:ext>
                </a:extLst>
              </p:cNvPr>
              <p:cNvSpPr txBox="1"/>
              <p:nvPr/>
            </p:nvSpPr>
            <p:spPr>
              <a:xfrm>
                <a:off x="14194684" y="-3082244"/>
                <a:ext cx="1692499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600"/>
                  </a:spcAft>
                </a:pPr>
                <a:r>
                  <a:rPr lang="en-GB" sz="1000" dirty="0"/>
                  <a:t>Foveal avascular zone</a:t>
                </a:r>
              </a:p>
              <a:p>
                <a:pPr>
                  <a:spcAft>
                    <a:spcPts val="600"/>
                  </a:spcAft>
                </a:pPr>
                <a:r>
                  <a:rPr lang="en-GB" sz="1000" dirty="0"/>
                  <a:t>Normal foveal depression </a:t>
                </a:r>
              </a:p>
              <a:p>
                <a:pPr>
                  <a:spcAft>
                    <a:spcPts val="600"/>
                  </a:spcAft>
                </a:pPr>
                <a:r>
                  <a:rPr lang="en-GB" sz="1000" dirty="0"/>
                  <a:t>Inner retinal thinning</a:t>
                </a: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29927BC-874E-4040-9F90-275617E9024A}"/>
                </a:ext>
              </a:extLst>
            </p:cNvPr>
            <p:cNvSpPr txBox="1"/>
            <p:nvPr/>
          </p:nvSpPr>
          <p:spPr>
            <a:xfrm>
              <a:off x="2843808" y="883612"/>
              <a:ext cx="707681" cy="306467"/>
            </a:xfrm>
            <a:prstGeom prst="round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Control 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35D7EE6-91CD-490A-8B7E-8DE43038736C}"/>
                </a:ext>
              </a:extLst>
            </p:cNvPr>
            <p:cNvSpPr txBox="1"/>
            <p:nvPr/>
          </p:nvSpPr>
          <p:spPr>
            <a:xfrm>
              <a:off x="4925840" y="867169"/>
              <a:ext cx="1368152" cy="306467"/>
            </a:xfrm>
            <a:prstGeom prst="round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Type 2 diabetes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8995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Simó</a:t>
            </a:r>
            <a:r>
              <a:rPr lang="en-GB" dirty="0"/>
              <a:t> et al (2018) Diabetologia DOI 10.1007/s00125-018-4692-1</a:t>
            </a:r>
          </a:p>
          <a:p>
            <a:r>
              <a:rPr lang="en-GB" sz="1200" dirty="0"/>
              <a:t>© The Authors 2018, except for image of glial activation in donor with type 2 diabetes (T2D): adapted from Carrasco et al (2008), distributed under the terms of the CC BY-NC-ND 3.0 License (http://creativecommons.org/licenses/by-nc-nd/3.0/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ain features of neurodegeneration: glial activation and neural apoptosis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4801B64-8585-471D-801E-D3BBE9C91C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8338" y="836712"/>
            <a:ext cx="5947324" cy="5024351"/>
          </a:xfrm>
          <a:prstGeom prst="rect">
            <a:avLst/>
          </a:prstGeom>
        </p:spPr>
      </p:pic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13920" y="5737162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64594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Simó</a:t>
            </a:r>
            <a:r>
              <a:rPr lang="en-GB" dirty="0"/>
              <a:t> et al (2018) Diabetologia DOI 10.1007/s00125-018-4692-1 </a:t>
            </a:r>
          </a:p>
          <a:p>
            <a:r>
              <a:rPr lang="en-GB" sz="1200" dirty="0"/>
              <a:t>© Elsevier. Adapted from </a:t>
            </a:r>
            <a:r>
              <a:rPr lang="en-GB" sz="1200" dirty="0" err="1"/>
              <a:t>Simó</a:t>
            </a:r>
            <a:r>
              <a:rPr lang="en-GB" sz="1200" dirty="0"/>
              <a:t> and Hernández (2014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ain mechanisms involved in the link between retinal neurodegeneration and microvascular impairment in diabet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AB5D452-D673-468F-B173-FC91CD37E1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2332" y="1087694"/>
            <a:ext cx="7045596" cy="4682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6138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354</Words>
  <Application>Microsoft Office PowerPoint</Application>
  <PresentationFormat>On-screen Show (4:3)</PresentationFormat>
  <Paragraphs>36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0</cp:revision>
  <dcterms:created xsi:type="dcterms:W3CDTF">2016-06-15T12:53:43Z</dcterms:created>
  <dcterms:modified xsi:type="dcterms:W3CDTF">2018-07-11T10:08:47Z</dcterms:modified>
</cp:coreProperties>
</file>